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89" autoAdjust="0"/>
    <p:restoredTop sz="95982" autoAdjust="0"/>
  </p:normalViewPr>
  <p:slideViewPr>
    <p:cSldViewPr showGuides="1">
      <p:cViewPr varScale="1">
        <p:scale>
          <a:sx n="97" d="100"/>
          <a:sy n="97" d="100"/>
        </p:scale>
        <p:origin x="2904" y="96"/>
      </p:cViewPr>
      <p:guideLst>
        <p:guide orient="horz" pos="2880"/>
        <p:guide pos="2160"/>
        <p:guide pos="28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30740;&#31350;\&#23455;&#39443;&#12487;&#12540;&#12479;\&#23546;&#26449;&#12487;&#12540;&#12479;\NMR\NMR%20&#26377;&#27231;&#28342;&#23186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602287581699341E-2"/>
          <c:y val="3.7341568971374757E-2"/>
          <c:w val="0.9102473856209149"/>
          <c:h val="0.71320577130528584"/>
        </c:manualLayout>
      </c:layout>
      <c:barChart>
        <c:barDir val="col"/>
        <c:grouping val="clustered"/>
        <c:varyColors val="0"/>
        <c:ser>
          <c:idx val="0"/>
          <c:order val="0"/>
          <c:tx>
            <c:v>Raw biomas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L$2:$L$48</c:f>
              <c:strCache>
                <c:ptCount val="29"/>
                <c:pt idx="0">
                  <c:v>p-Coumarate (1)</c:v>
                </c:pt>
                <c:pt idx="1">
                  <c:v>p-Coumarate (2)</c:v>
                </c:pt>
                <c:pt idx="2">
                  <c:v>p-Coumarate (3)</c:v>
                </c:pt>
                <c:pt idx="3">
                  <c:v>p-Coumarate (4)</c:v>
                </c:pt>
                <c:pt idx="4">
                  <c:v>p-Coumarate (5)</c:v>
                </c:pt>
                <c:pt idx="5">
                  <c:v>p-Coumarate (6)</c:v>
                </c:pt>
                <c:pt idx="6">
                  <c:v>Guaiacyl (7)</c:v>
                </c:pt>
                <c:pt idx="7">
                  <c:v>Guaiacyl (8)</c:v>
                </c:pt>
                <c:pt idx="8">
                  <c:v>Guaiacyl (9)</c:v>
                </c:pt>
                <c:pt idx="9">
                  <c:v>Guaiacyl (10)</c:v>
                </c:pt>
                <c:pt idx="10">
                  <c:v>Syringyl (11)</c:v>
                </c:pt>
                <c:pt idx="11">
                  <c:v>Syringyl (12)</c:v>
                </c:pt>
                <c:pt idx="12">
                  <c:v>p-Hydroxyphenyl (13)</c:v>
                </c:pt>
                <c:pt idx="13">
                  <c:v>Cinnamyl alcohol (14)</c:v>
                </c:pt>
                <c:pt idx="14">
                  <c:v>Ferulate (15)</c:v>
                </c:pt>
                <c:pt idx="15">
                  <c:v>Ferulate (16)</c:v>
                </c:pt>
                <c:pt idx="16">
                  <c:v>Methoxyl (17)</c:v>
                </c:pt>
                <c:pt idx="17">
                  <c:v>Methoxyl (18)</c:v>
                </c:pt>
                <c:pt idx="18">
                  <c:v>5-5/4-O-β (19)</c:v>
                </c:pt>
                <c:pt idx="19">
                  <c:v>5-5/4-O-β (20)</c:v>
                </c:pt>
                <c:pt idx="20">
                  <c:v>β-O-4 (21)</c:v>
                </c:pt>
                <c:pt idx="21">
                  <c:v>β-O-4 (22)</c:v>
                </c:pt>
                <c:pt idx="22">
                  <c:v>β-O-4 (23)</c:v>
                </c:pt>
                <c:pt idx="23">
                  <c:v>β-O-4-H/G (24)</c:v>
                </c:pt>
                <c:pt idx="24">
                  <c:v>β-O-4-H/G (25)</c:v>
                </c:pt>
                <c:pt idx="25">
                  <c:v>β-O-4-H/G (26)</c:v>
                </c:pt>
                <c:pt idx="26">
                  <c:v>β-O-4-H/G (27)</c:v>
                </c:pt>
                <c:pt idx="27">
                  <c:v>β-O-4-S (28)</c:v>
                </c:pt>
                <c:pt idx="28">
                  <c:v>β-5 (29)</c:v>
                </c:pt>
              </c:strCache>
            </c:strRef>
          </c:cat>
          <c:val>
            <c:numRef>
              <c:f>Sheet1!$M$2:$M$48</c:f>
              <c:numCache>
                <c:formatCode>General</c:formatCode>
                <c:ptCount val="29"/>
                <c:pt idx="0">
                  <c:v>2.248505143830263</c:v>
                </c:pt>
                <c:pt idx="1">
                  <c:v>3.8848118800556639</c:v>
                </c:pt>
                <c:pt idx="2">
                  <c:v>3.7650784283199785</c:v>
                </c:pt>
                <c:pt idx="3">
                  <c:v>2.2730892529214031</c:v>
                </c:pt>
                <c:pt idx="4">
                  <c:v>14.281018662667675</c:v>
                </c:pt>
                <c:pt idx="5">
                  <c:v>1.4695297954541122</c:v>
                </c:pt>
                <c:pt idx="6">
                  <c:v>1.4255530650111519</c:v>
                </c:pt>
                <c:pt idx="7">
                  <c:v>0.83253877729979098</c:v>
                </c:pt>
                <c:pt idx="8">
                  <c:v>3.8269997871299397</c:v>
                </c:pt>
                <c:pt idx="9">
                  <c:v>1.8937158851899627</c:v>
                </c:pt>
                <c:pt idx="10">
                  <c:v>1.2371300985556608</c:v>
                </c:pt>
                <c:pt idx="11">
                  <c:v>1.5553585271933559</c:v>
                </c:pt>
                <c:pt idx="12">
                  <c:v>0.84604689177940307</c:v>
                </c:pt>
                <c:pt idx="13">
                  <c:v>1.0674980778151271</c:v>
                </c:pt>
                <c:pt idx="14">
                  <c:v>1.3234365964936807</c:v>
                </c:pt>
                <c:pt idx="15">
                  <c:v>2.4516316331263939</c:v>
                </c:pt>
                <c:pt idx="16">
                  <c:v>21.720716069465539</c:v>
                </c:pt>
                <c:pt idx="17">
                  <c:v>37.967910632700651</c:v>
                </c:pt>
                <c:pt idx="18">
                  <c:v>1.7882514789703443</c:v>
                </c:pt>
                <c:pt idx="19">
                  <c:v>0.65366041188768087</c:v>
                </c:pt>
                <c:pt idx="20">
                  <c:v>1.700207468879668</c:v>
                </c:pt>
                <c:pt idx="21">
                  <c:v>1.3739420040286454</c:v>
                </c:pt>
                <c:pt idx="22">
                  <c:v>1.4834521328309176</c:v>
                </c:pt>
                <c:pt idx="23">
                  <c:v>85.156818513976347</c:v>
                </c:pt>
                <c:pt idx="24">
                  <c:v>1.7032273642873936</c:v>
                </c:pt>
                <c:pt idx="25">
                  <c:v>1.3163276896290979</c:v>
                </c:pt>
                <c:pt idx="26">
                  <c:v>1.4589617501096122</c:v>
                </c:pt>
                <c:pt idx="27">
                  <c:v>3.3266463275148852</c:v>
                </c:pt>
                <c:pt idx="28">
                  <c:v>0.62681177838638136</c:v>
                </c:pt>
              </c:numCache>
            </c:numRef>
          </c:val>
        </c:ser>
        <c:ser>
          <c:idx val="1"/>
          <c:order val="1"/>
          <c:tx>
            <c:v>Butanol_Lignin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L$2:$L$48</c:f>
              <c:strCache>
                <c:ptCount val="29"/>
                <c:pt idx="0">
                  <c:v>p-Coumarate (1)</c:v>
                </c:pt>
                <c:pt idx="1">
                  <c:v>p-Coumarate (2)</c:v>
                </c:pt>
                <c:pt idx="2">
                  <c:v>p-Coumarate (3)</c:v>
                </c:pt>
                <c:pt idx="3">
                  <c:v>p-Coumarate (4)</c:v>
                </c:pt>
                <c:pt idx="4">
                  <c:v>p-Coumarate (5)</c:v>
                </c:pt>
                <c:pt idx="5">
                  <c:v>p-Coumarate (6)</c:v>
                </c:pt>
                <c:pt idx="6">
                  <c:v>Guaiacyl (7)</c:v>
                </c:pt>
                <c:pt idx="7">
                  <c:v>Guaiacyl (8)</c:v>
                </c:pt>
                <c:pt idx="8">
                  <c:v>Guaiacyl (9)</c:v>
                </c:pt>
                <c:pt idx="9">
                  <c:v>Guaiacyl (10)</c:v>
                </c:pt>
                <c:pt idx="10">
                  <c:v>Syringyl (11)</c:v>
                </c:pt>
                <c:pt idx="11">
                  <c:v>Syringyl (12)</c:v>
                </c:pt>
                <c:pt idx="12">
                  <c:v>p-Hydroxyphenyl (13)</c:v>
                </c:pt>
                <c:pt idx="13">
                  <c:v>Cinnamyl alcohol (14)</c:v>
                </c:pt>
                <c:pt idx="14">
                  <c:v>Ferulate (15)</c:v>
                </c:pt>
                <c:pt idx="15">
                  <c:v>Ferulate (16)</c:v>
                </c:pt>
                <c:pt idx="16">
                  <c:v>Methoxyl (17)</c:v>
                </c:pt>
                <c:pt idx="17">
                  <c:v>Methoxyl (18)</c:v>
                </c:pt>
                <c:pt idx="18">
                  <c:v>5-5/4-O-β (19)</c:v>
                </c:pt>
                <c:pt idx="19">
                  <c:v>5-5/4-O-β (20)</c:v>
                </c:pt>
                <c:pt idx="20">
                  <c:v>β-O-4 (21)</c:v>
                </c:pt>
                <c:pt idx="21">
                  <c:v>β-O-4 (22)</c:v>
                </c:pt>
                <c:pt idx="22">
                  <c:v>β-O-4 (23)</c:v>
                </c:pt>
                <c:pt idx="23">
                  <c:v>β-O-4-H/G (24)</c:v>
                </c:pt>
                <c:pt idx="24">
                  <c:v>β-O-4-H/G (25)</c:v>
                </c:pt>
                <c:pt idx="25">
                  <c:v>β-O-4-H/G (26)</c:v>
                </c:pt>
                <c:pt idx="26">
                  <c:v>β-O-4-H/G (27)</c:v>
                </c:pt>
                <c:pt idx="27">
                  <c:v>β-O-4-S (28)</c:v>
                </c:pt>
                <c:pt idx="28">
                  <c:v>β-5 (29)</c:v>
                </c:pt>
              </c:strCache>
            </c:strRef>
          </c:cat>
          <c:val>
            <c:numRef>
              <c:f>Sheet1!$O$2:$O$48</c:f>
              <c:numCache>
                <c:formatCode>General</c:formatCode>
                <c:ptCount val="29"/>
                <c:pt idx="0">
                  <c:v>12.714256688968819</c:v>
                </c:pt>
                <c:pt idx="1">
                  <c:v>21.438594124114847</c:v>
                </c:pt>
                <c:pt idx="2">
                  <c:v>21.438594124114847</c:v>
                </c:pt>
                <c:pt idx="3">
                  <c:v>10.177212353332678</c:v>
                </c:pt>
                <c:pt idx="4">
                  <c:v>68.597015938167843</c:v>
                </c:pt>
                <c:pt idx="5">
                  <c:v>4.1931296116790211</c:v>
                </c:pt>
                <c:pt idx="6">
                  <c:v>2.9812268195506193</c:v>
                </c:pt>
                <c:pt idx="7">
                  <c:v>3.6955730643030251</c:v>
                </c:pt>
                <c:pt idx="8">
                  <c:v>28.296818639280744</c:v>
                </c:pt>
                <c:pt idx="9">
                  <c:v>18.863050269988989</c:v>
                </c:pt>
                <c:pt idx="10">
                  <c:v>4.8764402404513607</c:v>
                </c:pt>
                <c:pt idx="11">
                  <c:v>6.9690582795110965</c:v>
                </c:pt>
                <c:pt idx="12">
                  <c:v>2.5875194744377414</c:v>
                </c:pt>
                <c:pt idx="13">
                  <c:v>0.66437530106721299</c:v>
                </c:pt>
                <c:pt idx="14">
                  <c:v>3.7046998638515376</c:v>
                </c:pt>
                <c:pt idx="15">
                  <c:v>7.8975521287646471</c:v>
                </c:pt>
                <c:pt idx="16">
                  <c:v>102.27182744691453</c:v>
                </c:pt>
                <c:pt idx="17">
                  <c:v>154.19231611376819</c:v>
                </c:pt>
                <c:pt idx="18">
                  <c:v>0.79153859597835352</c:v>
                </c:pt>
                <c:pt idx="19">
                  <c:v>3.5389526234124065E-2</c:v>
                </c:pt>
                <c:pt idx="20">
                  <c:v>2.1829340605105152</c:v>
                </c:pt>
                <c:pt idx="21">
                  <c:v>1.9735080578506692</c:v>
                </c:pt>
                <c:pt idx="22">
                  <c:v>1.6610376714233808</c:v>
                </c:pt>
                <c:pt idx="23">
                  <c:v>12.297748914777218</c:v>
                </c:pt>
                <c:pt idx="24">
                  <c:v>6.3004205965677649</c:v>
                </c:pt>
                <c:pt idx="25">
                  <c:v>1.809823756585013</c:v>
                </c:pt>
                <c:pt idx="26">
                  <c:v>1.8274863664141352</c:v>
                </c:pt>
                <c:pt idx="27">
                  <c:v>0.36963656527137179</c:v>
                </c:pt>
                <c:pt idx="28">
                  <c:v>1.4256531161270241</c:v>
                </c:pt>
              </c:numCache>
            </c:numRef>
          </c:val>
        </c:ser>
        <c:ser>
          <c:idx val="2"/>
          <c:order val="2"/>
          <c:tx>
            <c:v>Pentanol_Lignin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L$2:$L$48</c:f>
              <c:strCache>
                <c:ptCount val="29"/>
                <c:pt idx="0">
                  <c:v>p-Coumarate (1)</c:v>
                </c:pt>
                <c:pt idx="1">
                  <c:v>p-Coumarate (2)</c:v>
                </c:pt>
                <c:pt idx="2">
                  <c:v>p-Coumarate (3)</c:v>
                </c:pt>
                <c:pt idx="3">
                  <c:v>p-Coumarate (4)</c:v>
                </c:pt>
                <c:pt idx="4">
                  <c:v>p-Coumarate (5)</c:v>
                </c:pt>
                <c:pt idx="5">
                  <c:v>p-Coumarate (6)</c:v>
                </c:pt>
                <c:pt idx="6">
                  <c:v>Guaiacyl (7)</c:v>
                </c:pt>
                <c:pt idx="7">
                  <c:v>Guaiacyl (8)</c:v>
                </c:pt>
                <c:pt idx="8">
                  <c:v>Guaiacyl (9)</c:v>
                </c:pt>
                <c:pt idx="9">
                  <c:v>Guaiacyl (10)</c:v>
                </c:pt>
                <c:pt idx="10">
                  <c:v>Syringyl (11)</c:v>
                </c:pt>
                <c:pt idx="11">
                  <c:v>Syringyl (12)</c:v>
                </c:pt>
                <c:pt idx="12">
                  <c:v>p-Hydroxyphenyl (13)</c:v>
                </c:pt>
                <c:pt idx="13">
                  <c:v>Cinnamyl alcohol (14)</c:v>
                </c:pt>
                <c:pt idx="14">
                  <c:v>Ferulate (15)</c:v>
                </c:pt>
                <c:pt idx="15">
                  <c:v>Ferulate (16)</c:v>
                </c:pt>
                <c:pt idx="16">
                  <c:v>Methoxyl (17)</c:v>
                </c:pt>
                <c:pt idx="17">
                  <c:v>Methoxyl (18)</c:v>
                </c:pt>
                <c:pt idx="18">
                  <c:v>5-5/4-O-β (19)</c:v>
                </c:pt>
                <c:pt idx="19">
                  <c:v>5-5/4-O-β (20)</c:v>
                </c:pt>
                <c:pt idx="20">
                  <c:v>β-O-4 (21)</c:v>
                </c:pt>
                <c:pt idx="21">
                  <c:v>β-O-4 (22)</c:v>
                </c:pt>
                <c:pt idx="22">
                  <c:v>β-O-4 (23)</c:v>
                </c:pt>
                <c:pt idx="23">
                  <c:v>β-O-4-H/G (24)</c:v>
                </c:pt>
                <c:pt idx="24">
                  <c:v>β-O-4-H/G (25)</c:v>
                </c:pt>
                <c:pt idx="25">
                  <c:v>β-O-4-H/G (26)</c:v>
                </c:pt>
                <c:pt idx="26">
                  <c:v>β-O-4-H/G (27)</c:v>
                </c:pt>
                <c:pt idx="27">
                  <c:v>β-O-4-S (28)</c:v>
                </c:pt>
                <c:pt idx="28">
                  <c:v>β-5 (29)</c:v>
                </c:pt>
              </c:strCache>
            </c:strRef>
          </c:cat>
          <c:val>
            <c:numRef>
              <c:f>Sheet1!$P$2:$P$48</c:f>
              <c:numCache>
                <c:formatCode>General</c:formatCode>
                <c:ptCount val="29"/>
                <c:pt idx="0">
                  <c:v>8.8602593231772673</c:v>
                </c:pt>
                <c:pt idx="1">
                  <c:v>23.519428545414666</c:v>
                </c:pt>
                <c:pt idx="2">
                  <c:v>23.519428545414666</c:v>
                </c:pt>
                <c:pt idx="3">
                  <c:v>8.923492627126711</c:v>
                </c:pt>
                <c:pt idx="4">
                  <c:v>66.519035380686915</c:v>
                </c:pt>
                <c:pt idx="5">
                  <c:v>2.8779194550323015</c:v>
                </c:pt>
                <c:pt idx="6">
                  <c:v>4.2731402273733696</c:v>
                </c:pt>
                <c:pt idx="7">
                  <c:v>4.2726195945023155</c:v>
                </c:pt>
                <c:pt idx="8">
                  <c:v>30.549124484229957</c:v>
                </c:pt>
                <c:pt idx="9">
                  <c:v>15.672120482226886</c:v>
                </c:pt>
                <c:pt idx="10">
                  <c:v>6.529643792756664</c:v>
                </c:pt>
                <c:pt idx="11">
                  <c:v>7.4209105695094548</c:v>
                </c:pt>
                <c:pt idx="12">
                  <c:v>2.2863356633516672</c:v>
                </c:pt>
                <c:pt idx="13">
                  <c:v>1.0213041480948064</c:v>
                </c:pt>
                <c:pt idx="14">
                  <c:v>2.3814658008765504</c:v>
                </c:pt>
                <c:pt idx="15">
                  <c:v>5.708975329947978</c:v>
                </c:pt>
                <c:pt idx="16">
                  <c:v>104.31068456186965</c:v>
                </c:pt>
                <c:pt idx="17">
                  <c:v>159.60670945954334</c:v>
                </c:pt>
                <c:pt idx="18">
                  <c:v>1.3929102053147595</c:v>
                </c:pt>
                <c:pt idx="19">
                  <c:v>3.1594717521489554E-2</c:v>
                </c:pt>
                <c:pt idx="20">
                  <c:v>2.6038170087199797</c:v>
                </c:pt>
                <c:pt idx="21">
                  <c:v>2.2441846798190617</c:v>
                </c:pt>
                <c:pt idx="22">
                  <c:v>1.8750307289274053</c:v>
                </c:pt>
                <c:pt idx="23">
                  <c:v>13.203906815820948</c:v>
                </c:pt>
                <c:pt idx="24">
                  <c:v>22.153973239967058</c:v>
                </c:pt>
                <c:pt idx="25">
                  <c:v>1.9801489059674129</c:v>
                </c:pt>
                <c:pt idx="26">
                  <c:v>2.0659010300915868</c:v>
                </c:pt>
                <c:pt idx="27">
                  <c:v>0.47920034432952996</c:v>
                </c:pt>
                <c:pt idx="28">
                  <c:v>1.7019691344995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99326720"/>
        <c:axId val="-299316928"/>
      </c:barChart>
      <c:catAx>
        <c:axId val="-29932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99316928"/>
        <c:crosses val="autoZero"/>
        <c:auto val="1"/>
        <c:lblAlgn val="ctr"/>
        <c:lblOffset val="100"/>
        <c:noMultiLvlLbl val="0"/>
      </c:catAx>
      <c:valAx>
        <c:axId val="-2993169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0" dirty="0"/>
                  <a:t>Peak intensity</a:t>
                </a:r>
                <a:endParaRPr lang="ja-JP" b="0" dirty="0"/>
              </a:p>
            </c:rich>
          </c:tx>
          <c:layout>
            <c:manualLayout>
              <c:xMode val="edge"/>
              <c:yMode val="edge"/>
              <c:x val="3.6310457516339871E-2"/>
              <c:y val="0.1625359259259259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9932672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2575915032679739"/>
          <c:y val="7.0435094359044492E-2"/>
          <c:w val="0.20453692810457516"/>
          <c:h val="0.1671437037037037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B54F9E-B317-470E-A6C0-1CD4130156B7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8A972A-3CEA-4486-8F38-43F2A1C8A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572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194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443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948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231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541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651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741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996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66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709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900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72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4895751"/>
              </p:ext>
            </p:extLst>
          </p:nvPr>
        </p:nvGraphicFramePr>
        <p:xfrm>
          <a:off x="384809" y="520764"/>
          <a:ext cx="6120000" cy="24923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5124595" y="934906"/>
            <a:ext cx="792000" cy="230832"/>
          </a:xfrm>
          <a:prstGeom prst="rect">
            <a:avLst/>
          </a:prstGeom>
          <a:solidFill>
            <a:schemeClr val="bg1"/>
          </a:solidFill>
        </p:spPr>
        <p:txBody>
          <a:bodyPr wrap="square" lIns="0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pentanol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124595" y="799076"/>
            <a:ext cx="792000" cy="230832"/>
          </a:xfrm>
          <a:prstGeom prst="rect">
            <a:avLst/>
          </a:prstGeom>
          <a:solidFill>
            <a:schemeClr val="bg1"/>
          </a:solidFill>
        </p:spPr>
        <p:txBody>
          <a:bodyPr wrap="square" lIns="0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butanol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124595" y="653477"/>
            <a:ext cx="711092" cy="230832"/>
          </a:xfrm>
          <a:prstGeom prst="rect">
            <a:avLst/>
          </a:prstGeom>
          <a:solidFill>
            <a:schemeClr val="bg1"/>
          </a:solidFill>
        </p:spPr>
        <p:txBody>
          <a:bodyPr wrap="none" lIns="0" rtlCol="0">
            <a:spAutoFit/>
          </a:bodyPr>
          <a:lstStyle/>
          <a:p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w biomass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678139" y="3158671"/>
            <a:ext cx="353334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_file_2 as PPTX</a:t>
            </a:r>
            <a:endParaRPr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83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6</TotalTime>
  <Words>9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寺村浩</cp:lastModifiedBy>
  <cp:revision>38</cp:revision>
  <dcterms:created xsi:type="dcterms:W3CDTF">2015-11-18T01:14:49Z</dcterms:created>
  <dcterms:modified xsi:type="dcterms:W3CDTF">2015-12-16T07:53:36Z</dcterms:modified>
</cp:coreProperties>
</file>